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5">
  <p:sldMasterIdLst>
    <p:sldMasterId id="2147483648" r:id="rId4"/>
  </p:sldMasterIdLst>
  <p:notesMasterIdLst>
    <p:notesMasterId r:id="rId6"/>
  </p:notesMasterIdLst>
  <p:sldIdLst>
    <p:sldId id="29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A31C418-18D7-FC01-4DB0-DB8C5F15C850}" name="Aziana Abu Hassan" initials="AAH" userId="Aziana Abu Hassan" providerId="None"/>
  <p188:author id="{307D5664-BCA0-BEA9-4FF5-496CF704CFAE}" name="Marko Hanzevacki (staff)" initials="MH(" userId="Marko Hanzevacki (staff)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EFA"/>
    <a:srgbClr val="FFA000"/>
    <a:srgbClr val="02FF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65" autoAdjust="0"/>
    <p:restoredTop sz="85830" autoAdjust="0"/>
  </p:normalViewPr>
  <p:slideViewPr>
    <p:cSldViewPr snapToGrid="0">
      <p:cViewPr varScale="1">
        <p:scale>
          <a:sx n="96" d="100"/>
          <a:sy n="96" d="100"/>
        </p:scale>
        <p:origin x="112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ca Pordea (staff)" userId="04217c9e-4602-4538-8d25-5638668eb9f5" providerId="ADAL" clId="{CD7F9C85-81FE-4AC2-855E-B48D0A98966B}"/>
    <pc:docChg chg="undo custSel delSld modSld">
      <pc:chgData name="Anca Pordea (staff)" userId="04217c9e-4602-4538-8d25-5638668eb9f5" providerId="ADAL" clId="{CD7F9C85-81FE-4AC2-855E-B48D0A98966B}" dt="2023-12-19T19:14:19.988" v="22" actId="14100"/>
      <pc:docMkLst>
        <pc:docMk/>
      </pc:docMkLst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773720066" sldId="256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406690983" sldId="257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309942647" sldId="258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56002129" sldId="262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051766301" sldId="263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1729401590" sldId="264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1128189669" sldId="265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3808561837" sldId="266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3005349361" sldId="267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290462980" sldId="268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1479637886" sldId="271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232706692" sldId="277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441496266" sldId="278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1672111689" sldId="279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2141721781" sldId="280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41255541" sldId="281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272614583" sldId="285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751480510" sldId="288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59477596" sldId="289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1090511444" sldId="290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804230355" sldId="293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1079981970" sldId="294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567409985" sldId="295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446155509" sldId="297"/>
        </pc:sldMkLst>
      </pc:sldChg>
      <pc:sldChg chg="addSp modSp mod">
        <pc:chgData name="Anca Pordea (staff)" userId="04217c9e-4602-4538-8d25-5638668eb9f5" providerId="ADAL" clId="{CD7F9C85-81FE-4AC2-855E-B48D0A98966B}" dt="2023-12-19T19:14:19.988" v="22" actId="14100"/>
        <pc:sldMkLst>
          <pc:docMk/>
          <pc:sldMk cId="1702511720" sldId="298"/>
        </pc:sldMkLst>
        <pc:spChg chg="add mod">
          <ac:chgData name="Anca Pordea (staff)" userId="04217c9e-4602-4538-8d25-5638668eb9f5" providerId="ADAL" clId="{CD7F9C85-81FE-4AC2-855E-B48D0A98966B}" dt="2023-12-19T19:14:19.988" v="22" actId="14100"/>
          <ac:spMkLst>
            <pc:docMk/>
            <pc:sldMk cId="1702511720" sldId="298"/>
            <ac:spMk id="4" creationId="{6EEBD144-FDCA-7B25-38D0-D3439FE92CD1}"/>
          </ac:spMkLst>
        </pc:spChg>
        <pc:graphicFrameChg chg="mod modGraphic">
          <ac:chgData name="Anca Pordea (staff)" userId="04217c9e-4602-4538-8d25-5638668eb9f5" providerId="ADAL" clId="{CD7F9C85-81FE-4AC2-855E-B48D0A98966B}" dt="2023-12-19T19:14:15.298" v="21" actId="14100"/>
          <ac:graphicFrameMkLst>
            <pc:docMk/>
            <pc:sldMk cId="1702511720" sldId="298"/>
            <ac:graphicFrameMk id="3" creationId="{DE622F3D-FD0B-2D44-3F61-42305DF1223C}"/>
          </ac:graphicFrameMkLst>
        </pc:graphicFrameChg>
      </pc:sldChg>
      <pc:sldChg chg="del">
        <pc:chgData name="Anca Pordea (staff)" userId="04217c9e-4602-4538-8d25-5638668eb9f5" providerId="ADAL" clId="{CD7F9C85-81FE-4AC2-855E-B48D0A98966B}" dt="2023-12-18T19:19:40.287" v="2" actId="47"/>
        <pc:sldMkLst>
          <pc:docMk/>
          <pc:sldMk cId="4077862176" sldId="299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4281819590" sldId="301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532461093" sldId="302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825408573" sldId="305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567219672" sldId="306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023848852" sldId="308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92132675" sldId="309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165866896" sldId="310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892218898" sldId="311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3710938837" sldId="312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3756588774" sldId="314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1331867037" sldId="315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351316601" sldId="316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026450018" sldId="317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1156295227" sldId="318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243933656" sldId="319"/>
        </pc:sldMkLst>
      </pc:sldChg>
      <pc:sldChg chg="del">
        <pc:chgData name="Anca Pordea (staff)" userId="04217c9e-4602-4538-8d25-5638668eb9f5" providerId="ADAL" clId="{CD7F9C85-81FE-4AC2-855E-B48D0A98966B}" dt="2023-12-18T19:19:06.311" v="1" actId="47"/>
        <pc:sldMkLst>
          <pc:docMk/>
          <pc:sldMk cId="2633288119" sldId="320"/>
        </pc:sldMkLst>
      </pc:sldChg>
      <pc:sldChg chg="del">
        <pc:chgData name="Anca Pordea (staff)" userId="04217c9e-4602-4538-8d25-5638668eb9f5" providerId="ADAL" clId="{CD7F9C85-81FE-4AC2-855E-B48D0A98966B}" dt="2023-12-18T19:18:59.240" v="0" actId="47"/>
        <pc:sldMkLst>
          <pc:docMk/>
          <pc:sldMk cId="95252591" sldId="32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86DAC8-0F5C-40C4-9048-03E5F0338584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82B562-5671-4D39-9920-23E3852B6F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84031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4 Table.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 of residues interacting with the docked </a:t>
            </a:r>
            <a:r>
              <a:rPr lang="en-GB" sz="1800" b="1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s-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4-polyisoprene, extracted from PLIP analysis of 10 docking poses obtained using </a:t>
            </a:r>
            <a:r>
              <a:rPr lang="en-GB" sz="18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PLP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GB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ocking solutions were ranked based on the fitness score from highest to lowest. Residues that interact with all / most poses are highlighted in grey and light grey, respectively. </a:t>
            </a:r>
            <a:endParaRPr lang="en-MY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082B562-5671-4D39-9920-23E3852B6FD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49502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839CC-2F4F-9676-481C-A8C6BD60D3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B78B30-6C9E-9383-5A22-347469CEE2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F3B91-4E34-CF19-361A-C8592EC86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C2D85-0EFD-F1E1-E255-D409A42D7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04A4AE-7753-7C00-721D-98EB26BA0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39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1454C2-05D2-40B2-C98F-42188163E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A9FF01-EC14-452C-3CE0-F69E790709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E166A-724F-0654-6132-EB6D136E6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5865FF-D369-A9FB-BE86-F396D4D2EA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AD3664-4433-2CAF-0724-6D43A5EDC0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9828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3E88ECF-540D-9D8B-AA3D-0BFBCF95FBE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DF5B47-A83B-3433-E305-0968F562A8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4D5D9-63A2-6610-C517-62DD48C0F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9AA1-97FE-DF9C-A3CB-5C208B826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75377F-1DCC-3F4C-1493-4EB469A4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912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743F2-CAC8-CCE5-22CC-8CCBCD2DF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F9F779-89A1-544A-951D-A892F041EA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29A8DE-F0E3-F7D3-F0D4-FF0540892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D0439-C25F-AD3D-FB4B-F9C044F03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2FB56-DEEF-B1EC-BB2B-6B06B28E5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120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D81C7-B648-ECBB-EB5A-190AA87800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B8D037-CFF8-3CAE-B59F-42FF4DE9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928D-3201-D840-2A36-11982338F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EDBB0-1CBA-B1A9-36C6-CD364295E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EA93A-115B-D044-5063-CCA7ACB1C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7324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D1655-2CC5-8A36-679E-B66A3C818B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E9BB75-23E1-8048-21F0-8291ADA465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1A3F4A-1C5D-7B02-8B21-9555A35726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4E35E8-F04A-5333-D410-00E243298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A075AA-CC28-DF86-0F94-4D99C3AC99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BFF910-1687-8D7A-1E60-FB4E3700E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421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6B51B-A49C-DB81-129D-770B7B81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3D9DB3-E956-030A-1DF5-3FB9D03B44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D2E3A9-FCD4-5AFE-85C4-F8F4DDA715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A0BCEB-5EF9-7EE9-599C-6B94A4674A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392368-689C-6BF0-C77F-0FC8D9730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21DC13-1D6B-88D7-E33B-841299F68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249E9-F2D9-4CE8-E6E4-69784C9156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5DCCF0F-0559-9B9A-9D3B-F937169A29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448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E970B-DA53-0A74-ECA7-73762CEB39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14DDAA-CD12-6445-0D2D-6426A9B8D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E4ED273-A5E0-4AA0-9FB8-376853020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4533B-EB08-5EF6-12E6-A61B91BB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0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CCA8A7-6C30-3E41-FDA4-305B64DA9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8FDF7-8B82-C3B9-B1D3-F8A0D4019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B7E57B-3FA1-1E79-D470-B0A644558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197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032A7-73AA-3738-F12D-A9F0F15F7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9093D-A355-AE1D-2978-2A67002740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E4AE4-E591-8AD3-0D49-79DAC0AD2F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C028F-B9A0-811D-83B5-8780FC264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1EC2C9-44C6-5DDA-05D2-3CBF197BF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A6038-8120-45EA-B5FE-EDC53B703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9556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EFBDF-8326-737F-3DE1-8A0F176EF2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5A8341-5D99-22B5-5588-0F213643C6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1F0F35-0A56-8640-3CB0-13C12B4769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94D0A3-D271-0D2E-F074-B7ACC0632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72C26D-735A-EDE8-811B-C6F37C007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E86F7-F0E0-0A6F-02B3-303AB6C43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266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F7FA97-498A-322A-7FC1-14CEFA006F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761D6-4CC6-BD9F-31FF-4C66405D9E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92A81E-83E9-C733-B6FA-CCC1763CC7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0E7EF-C829-4B3C-B48A-A4139DBFC10A}" type="datetimeFigureOut">
              <a:rPr lang="en-GB" smtClean="0"/>
              <a:t>19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D18AAE-C4F2-C908-CFD8-36D483C0CB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562CB5-FAC8-96AE-9FC4-FD1DF197A0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57DE2-9BB7-43B8-A980-9DF82923D3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404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E622F3D-FD0B-2D44-3F61-42305DF122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9100770"/>
              </p:ext>
            </p:extLst>
          </p:nvPr>
        </p:nvGraphicFramePr>
        <p:xfrm>
          <a:off x="2703444" y="133179"/>
          <a:ext cx="5754758" cy="6591641"/>
        </p:xfrm>
        <a:graphic>
          <a:graphicData uri="http://schemas.openxmlformats.org/drawingml/2006/table">
            <a:tbl>
              <a:tblPr firstRow="1" firstCol="1" bandRow="1"/>
              <a:tblGrid>
                <a:gridCol w="686428">
                  <a:extLst>
                    <a:ext uri="{9D8B030D-6E8A-4147-A177-3AD203B41FA5}">
                      <a16:colId xmlns:a16="http://schemas.microsoft.com/office/drawing/2014/main" val="239293150"/>
                    </a:ext>
                  </a:extLst>
                </a:gridCol>
                <a:gridCol w="998352">
                  <a:extLst>
                    <a:ext uri="{9D8B030D-6E8A-4147-A177-3AD203B41FA5}">
                      <a16:colId xmlns:a16="http://schemas.microsoft.com/office/drawing/2014/main" val="2648008661"/>
                    </a:ext>
                  </a:extLst>
                </a:gridCol>
                <a:gridCol w="628933">
                  <a:extLst>
                    <a:ext uri="{9D8B030D-6E8A-4147-A177-3AD203B41FA5}">
                      <a16:colId xmlns:a16="http://schemas.microsoft.com/office/drawing/2014/main" val="1576537820"/>
                    </a:ext>
                  </a:extLst>
                </a:gridCol>
                <a:gridCol w="346551">
                  <a:extLst>
                    <a:ext uri="{9D8B030D-6E8A-4147-A177-3AD203B41FA5}">
                      <a16:colId xmlns:a16="http://schemas.microsoft.com/office/drawing/2014/main" val="1544300576"/>
                    </a:ext>
                  </a:extLst>
                </a:gridCol>
                <a:gridCol w="346551">
                  <a:extLst>
                    <a:ext uri="{9D8B030D-6E8A-4147-A177-3AD203B41FA5}">
                      <a16:colId xmlns:a16="http://schemas.microsoft.com/office/drawing/2014/main" val="4086492106"/>
                    </a:ext>
                  </a:extLst>
                </a:gridCol>
                <a:gridCol w="346551">
                  <a:extLst>
                    <a:ext uri="{9D8B030D-6E8A-4147-A177-3AD203B41FA5}">
                      <a16:colId xmlns:a16="http://schemas.microsoft.com/office/drawing/2014/main" val="1098656711"/>
                    </a:ext>
                  </a:extLst>
                </a:gridCol>
                <a:gridCol w="346551">
                  <a:extLst>
                    <a:ext uri="{9D8B030D-6E8A-4147-A177-3AD203B41FA5}">
                      <a16:colId xmlns:a16="http://schemas.microsoft.com/office/drawing/2014/main" val="235307749"/>
                    </a:ext>
                  </a:extLst>
                </a:gridCol>
                <a:gridCol w="346551">
                  <a:extLst>
                    <a:ext uri="{9D8B030D-6E8A-4147-A177-3AD203B41FA5}">
                      <a16:colId xmlns:a16="http://schemas.microsoft.com/office/drawing/2014/main" val="2019727301"/>
                    </a:ext>
                  </a:extLst>
                </a:gridCol>
                <a:gridCol w="346551">
                  <a:extLst>
                    <a:ext uri="{9D8B030D-6E8A-4147-A177-3AD203B41FA5}">
                      <a16:colId xmlns:a16="http://schemas.microsoft.com/office/drawing/2014/main" val="2658968859"/>
                    </a:ext>
                  </a:extLst>
                </a:gridCol>
                <a:gridCol w="346551">
                  <a:extLst>
                    <a:ext uri="{9D8B030D-6E8A-4147-A177-3AD203B41FA5}">
                      <a16:colId xmlns:a16="http://schemas.microsoft.com/office/drawing/2014/main" val="3371717286"/>
                    </a:ext>
                  </a:extLst>
                </a:gridCol>
                <a:gridCol w="507594">
                  <a:extLst>
                    <a:ext uri="{9D8B030D-6E8A-4147-A177-3AD203B41FA5}">
                      <a16:colId xmlns:a16="http://schemas.microsoft.com/office/drawing/2014/main" val="1687821035"/>
                    </a:ext>
                  </a:extLst>
                </a:gridCol>
                <a:gridCol w="507594">
                  <a:extLst>
                    <a:ext uri="{9D8B030D-6E8A-4147-A177-3AD203B41FA5}">
                      <a16:colId xmlns:a16="http://schemas.microsoft.com/office/drawing/2014/main" val="3510768661"/>
                    </a:ext>
                  </a:extLst>
                </a:gridCol>
              </a:tblGrid>
              <a:tr h="166453">
                <a:tc rowSpan="2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esidue number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No of poses interacting with residue 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0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ose rank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956461"/>
                  </a:ext>
                </a:extLst>
              </a:tr>
              <a:tr h="254500">
                <a:tc v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MY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5072335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S8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3464727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YR13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2380354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T14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7389155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14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2442255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LU14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9625656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15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6704169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A159</a:t>
                      </a:r>
                      <a:endParaRPr lang="en-MY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1294436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P16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0427107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RG16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3601709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S16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1129820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16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3890815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RG17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4384575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17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9629772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YR17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563791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P17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9140219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17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0990448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18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7663231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19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5179769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S19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3068963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19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9302553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19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2993963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22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1936171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22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2412692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HR23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2019120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P23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6861294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23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7589394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RP26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1766198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A26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204451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26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7585305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29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2417652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EU29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0886486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LU39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3395392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RG395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9120532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396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 b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0612037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LA397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3540211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LE398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689175"/>
                  </a:ext>
                </a:extLst>
              </a:tr>
              <a:tr h="1664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SP399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MY" sz="9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/</a:t>
                      </a:r>
                      <a:endParaRPr lang="en-MY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MY" sz="10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743" marR="23743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25281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6EEBD144-FDCA-7B25-38D0-D3439FE92CD1}"/>
              </a:ext>
            </a:extLst>
          </p:cNvPr>
          <p:cNvSpPr txBox="1"/>
          <p:nvPr/>
        </p:nvSpPr>
        <p:spPr>
          <a:xfrm>
            <a:off x="275810" y="365228"/>
            <a:ext cx="2278547" cy="19543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4 Table.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ist of residues interacting with the docked </a:t>
            </a:r>
            <a:r>
              <a:rPr lang="en-GB" sz="1100" b="1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s-</a:t>
            </a: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4-polyisoprene, extracted from PLIP analysis of 10 docking poses obtained using </a:t>
            </a:r>
            <a:r>
              <a:rPr lang="en-GB" sz="1100" b="1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PLP</a:t>
            </a:r>
            <a:r>
              <a:rPr lang="en-GB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GB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ocking solutions were ranked based on the fitness score from highest to lowest. Residues that interact with all / most poses are highlighted in grey and light grey, respectively. </a:t>
            </a:r>
            <a:endParaRPr lang="en-MY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2511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7573F99DE79145B2C4B20841E12603" ma:contentTypeVersion="17" ma:contentTypeDescription="Create a new document." ma:contentTypeScope="" ma:versionID="75a924c6fce2bfbfdafe8aa5030a8127">
  <xsd:schema xmlns:xsd="http://www.w3.org/2001/XMLSchema" xmlns:xs="http://www.w3.org/2001/XMLSchema" xmlns:p="http://schemas.microsoft.com/office/2006/metadata/properties" xmlns:ns3="0c1e910d-4918-42f1-af2c-ed1101d63abc" xmlns:ns4="786e620f-b1da-4f59-878c-ef7546d25bf1" targetNamespace="http://schemas.microsoft.com/office/2006/metadata/properties" ma:root="true" ma:fieldsID="84345ca33903240b6bb317a7195b494d" ns3:_="" ns4:_="">
    <xsd:import namespace="0c1e910d-4918-42f1-af2c-ed1101d63abc"/>
    <xsd:import namespace="786e620f-b1da-4f59-878c-ef7546d25bf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OCR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c1e910d-4918-42f1-af2c-ed1101d63ab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Location" ma:index="12" nillable="true" ma:displayName="MediaServiceLocation" ma:description="" ma:internalName="MediaServiceLocation" ma:readOnly="true">
      <xsd:simpleType>
        <xsd:restriction base="dms:Text"/>
      </xsd:simpleType>
    </xsd:element>
    <xsd:element name="MediaServiceOCR" ma:index="13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6e620f-b1da-4f59-878c-ef7546d25bf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c1e910d-4918-42f1-af2c-ed1101d63abc" xsi:nil="true"/>
  </documentManagement>
</p:properties>
</file>

<file path=customXml/itemProps1.xml><?xml version="1.0" encoding="utf-8"?>
<ds:datastoreItem xmlns:ds="http://schemas.openxmlformats.org/officeDocument/2006/customXml" ds:itemID="{58BC3993-CD11-46D5-AFD3-539F9D1D026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5A7B98B-2C55-48C5-B622-1549557E3C5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c1e910d-4918-42f1-af2c-ed1101d63abc"/>
    <ds:schemaRef ds:uri="786e620f-b1da-4f59-878c-ef7546d25b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555A585-BC5A-4ACF-8F83-4E3A66BDD946}">
  <ds:schemaRefs>
    <ds:schemaRef ds:uri="786e620f-b1da-4f59-878c-ef7546d25bf1"/>
    <ds:schemaRef ds:uri="http://www.w3.org/XML/1998/namespace"/>
    <ds:schemaRef ds:uri="http://purl.org/dc/elements/1.1/"/>
    <ds:schemaRef ds:uri="http://schemas.microsoft.com/office/2006/documentManagement/types"/>
    <ds:schemaRef ds:uri="http://purl.org/dc/terms/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0c1e910d-4918-42f1-af2c-ed1101d63abc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413</TotalTime>
  <Words>317</Words>
  <Application>Microsoft Office PowerPoint</Application>
  <PresentationFormat>Widescreen</PresentationFormat>
  <Paragraphs>20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o Hanzevacki (staff)</dc:creator>
  <cp:lastModifiedBy>Anca Pordea (staff)</cp:lastModifiedBy>
  <cp:revision>365</cp:revision>
  <dcterms:created xsi:type="dcterms:W3CDTF">2022-09-23T18:06:25Z</dcterms:created>
  <dcterms:modified xsi:type="dcterms:W3CDTF">2023-12-19T19:14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7573F99DE79145B2C4B20841E12603</vt:lpwstr>
  </property>
</Properties>
</file>